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A226C9-33D9-41BC-AA81-1C3BA8611D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80C14-2DF7-44BB-8235-596754676A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9FD27-B940-4E31-A1B0-EBEF5B4EDD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74F81B-8212-487A-B354-20BD5AE8D8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45CC7-D572-4E0C-AC54-0DA2F34C6C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658CE-CB06-4520-806F-1A75C2B319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D8E3F-6E43-469D-93C8-880E96047D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130329-25C5-4EEA-B8ED-8CA1790CF3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834CC-3D0F-409C-9FC8-1F5BEAA3EC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9C41A-F7B1-40BB-B42A-65FB9BEFEA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FCB0B3-9E86-4CC0-9E5F-BB6F2FFCBD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FA107-CBC4-4B21-BB0E-3EFD28B2A1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611EAA-BB2D-44A6-9EE0-0FC85C4F53EA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000000"/>
                </a:solidFill>
                <a:latin typeface="Calibri Light"/>
              </a:rPr>
              <a:t>Supplementary figure 1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1"/>
          <a:stretch/>
        </p:blipFill>
        <p:spPr>
          <a:xfrm>
            <a:off x="3629160" y="1714680"/>
            <a:ext cx="4933800" cy="3429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000000"/>
                </a:solidFill>
                <a:latin typeface="Calibri Light"/>
              </a:rPr>
              <a:t>Supplementary figure 2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44" name="Picture 2" descr=""/>
          <p:cNvPicPr/>
          <p:nvPr/>
        </p:nvPicPr>
        <p:blipFill>
          <a:blip r:embed="rId1"/>
          <a:stretch/>
        </p:blipFill>
        <p:spPr>
          <a:xfrm>
            <a:off x="3129120" y="1536840"/>
            <a:ext cx="5487840" cy="4119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000000"/>
                </a:solidFill>
                <a:latin typeface="Calibri Light"/>
              </a:rPr>
              <a:t>Supplementary figure 3a and 3b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>
            <a:off x="2676600" y="1809720"/>
            <a:ext cx="6838920" cy="3238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000000"/>
                </a:solidFill>
                <a:latin typeface="Calibri Light"/>
              </a:rPr>
              <a:t>Supplementary figure 3c and 3d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2676600" y="1893960"/>
            <a:ext cx="6838920" cy="3070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6-21T20:23:41Z</dcterms:created>
  <dc:creator>Charlene</dc:creator>
  <dc:description/>
  <dc:language>en-US</dc:language>
  <cp:lastModifiedBy>Charlene</cp:lastModifiedBy>
  <dcterms:modified xsi:type="dcterms:W3CDTF">2016-06-22T08:20:54Z</dcterms:modified>
  <cp:revision>2</cp:revision>
  <dc:subject/>
  <dc:title>Supplementary figure 1</dc:title>
</cp:coreProperties>
</file>